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14737684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4D4D4D"/>
    <a:srgbClr val="969696"/>
    <a:srgbClr val="C3C3C3"/>
    <a:srgbClr val="E6E6E6"/>
    <a:srgbClr val="5F5F5F"/>
    <a:srgbClr val="FAE2E3"/>
    <a:srgbClr val="9ECFE6"/>
    <a:srgbClr val="D3D3D3"/>
    <a:srgbClr val="73737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88" autoAdjust="0"/>
    <p:restoredTop sz="94669" autoAdjust="0"/>
  </p:normalViewPr>
  <p:slideViewPr>
    <p:cSldViewPr snapToGrid="0">
      <p:cViewPr varScale="1">
        <p:scale>
          <a:sx n="67" d="100"/>
          <a:sy n="67" d="100"/>
        </p:scale>
        <p:origin x="612" y="60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200" d="100"/>
        <a:sy n="200" d="100"/>
      </p:scale>
      <p:origin x="0" y="-28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yazaki%20Tadashi\Desktop\231108_paper_Fig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standard"/>
        <c:varyColors val="0"/>
        <c:ser>
          <c:idx val="0"/>
          <c:order val="0"/>
          <c:tx>
            <c:strRef>
              <c:f>Sheet1!$F$5</c:f>
              <c:strCache>
                <c:ptCount val="1"/>
                <c:pt idx="0">
                  <c:v>Low_VF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  <a:sp3d/>
          </c:spPr>
          <c:invertIfNegative val="0"/>
          <c:cat>
            <c:strRef>
              <c:f>Sheet1!$E$13:$E$14</c:f>
              <c:strCache>
                <c:ptCount val="2"/>
                <c:pt idx="0">
                  <c:v>Non-Eldery</c:v>
                </c:pt>
                <c:pt idx="1">
                  <c:v>Eldery</c:v>
                </c:pt>
              </c:strCache>
            </c:strRef>
          </c:cat>
          <c:val>
            <c:numRef>
              <c:f>Sheet1!$F$13:$F$14</c:f>
              <c:numCache>
                <c:formatCode>General</c:formatCode>
                <c:ptCount val="2"/>
                <c:pt idx="0">
                  <c:v>1</c:v>
                </c:pt>
                <c:pt idx="1">
                  <c:v>3.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09-40C0-A4A5-6CD1F6E15D7D}"/>
            </c:ext>
          </c:extLst>
        </c:ser>
        <c:ser>
          <c:idx val="1"/>
          <c:order val="1"/>
          <c:tx>
            <c:strRef>
              <c:f>Sheet1!$G$5</c:f>
              <c:strCache>
                <c:ptCount val="1"/>
                <c:pt idx="0">
                  <c:v>High_VF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  <a:sp3d/>
          </c:spPr>
          <c:invertIfNegative val="0"/>
          <c:cat>
            <c:strRef>
              <c:f>Sheet1!$E$13:$E$14</c:f>
              <c:strCache>
                <c:ptCount val="2"/>
                <c:pt idx="0">
                  <c:v>Non-Eldery</c:v>
                </c:pt>
                <c:pt idx="1">
                  <c:v>Eldery</c:v>
                </c:pt>
              </c:strCache>
            </c:strRef>
          </c:cat>
          <c:val>
            <c:numRef>
              <c:f>Sheet1!$G$13:$G$14</c:f>
              <c:numCache>
                <c:formatCode>General</c:formatCode>
                <c:ptCount val="2"/>
                <c:pt idx="0">
                  <c:v>1.87</c:v>
                </c:pt>
                <c:pt idx="1">
                  <c:v>6.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09-40C0-A4A5-6CD1F6E15D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05337344"/>
        <c:axId val="205338880"/>
        <c:axId val="204297984"/>
      </c:bar3DChart>
      <c:catAx>
        <c:axId val="205337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5338880"/>
        <c:crosses val="autoZero"/>
        <c:auto val="1"/>
        <c:lblAlgn val="ctr"/>
        <c:lblOffset val="100"/>
        <c:noMultiLvlLbl val="0"/>
      </c:catAx>
      <c:valAx>
        <c:axId val="2053388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5337344"/>
        <c:crosses val="autoZero"/>
        <c:crossBetween val="between"/>
      </c:valAx>
      <c:serAx>
        <c:axId val="20429798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5338880"/>
        <c:crosses val="autoZero"/>
      </c:ser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AA2023-E659-4B78-B120-060AF7E9ED20}" type="datetimeFigureOut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EC36D9-1DA4-4E7F-8660-634CD688E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6447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0BAFB7-A737-42CA-A309-B14D0A4ACC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ACE0781-446D-491A-8A25-EA09B55D65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6782D63-400B-4B83-9ECD-28C755908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895D0-65F7-4F1C-AF8E-C39D6BCC7E1D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BFA3A4E-BB1C-4567-AB21-2F98C2976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DF513D-98DC-42D5-82F3-C1E1B3EA1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6891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B4FF4A-533E-4EEE-AC28-E3AA03BDA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6B98625-43D6-4C95-80CC-859863BCD9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75B4F1-89B4-49A1-9A8C-135E3BBC0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3F789D-49CD-4DDF-87EB-4C20913449AB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46B809-28B9-484D-8BD7-CD18DC5DC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7FEDC2-01C8-4E8E-B905-9CEA137DB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29710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3204A01-C7EE-46AA-9C05-1867C30193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89742F0-BF7A-4089-AF29-DED5204960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8A7AC4-A6AC-49CC-AB00-A007D2106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E7C01-FA04-4F8C-B771-E11188130AE0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16AA87-6636-4C4B-9EE2-6B81284FE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6B5349-6D27-4F28-B5A7-44EB2DD8B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79527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16C87C-47B3-4639-88EE-ADAD7E782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F965C1D-5C67-4744-AC18-CB2F960793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EE8E21-6470-456A-8A01-5698C8352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149C-8DD9-456F-BD8E-4E69913A7A52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5012AC-2689-4EBF-9E19-D90C10056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258FB24-C36E-43C0-88A5-10F575B7B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13132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1689934-BEA5-418C-B466-B0463E07B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E6B25FB-F72C-4CFF-8981-B89A9B0D00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3B290D-2766-481A-9447-370865F88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C1888-BEC6-4B21-B075-EB59E7FD948E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2F6188-B6F2-4B84-8CD3-551F8631D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E56E6D-3220-4617-9E33-FC12C473D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10974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AE80A7-A344-425E-9346-05CFF61BA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55FAB70-4F24-48B4-8D94-8749E79BE3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A1D6D18-637E-4380-87CF-5CD0697B54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97E1DA-6EA1-4C4A-8D9D-2B22078B8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93083-58CB-40BE-A001-05091AABF28A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3EEA33A-1279-484A-A49A-9A03D8F91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1D10B87-37B1-42CA-A5D8-07154E9CE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0857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C9BC41-022D-42AE-94C8-B852016F1D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5E14EA-F461-461B-B317-A298E1DF44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36CDCDB-9549-4BF1-BEED-EDC1ACDE74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C088CE8-A7B9-4E96-9600-EA7A4A907E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4949AC2-2353-4B2D-ADFC-95B25E6825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3B96DB1-EB25-49DC-87A9-27FF3201C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44020-04BA-490E-B543-90DCD743D26C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4C41097-B0D6-4308-B2AF-904CC63D4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6FC5FC3-3F95-45B6-8D71-CEF110A86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08446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0FBC40-8966-43D8-8C1B-9F4C24B73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1765976-24F8-44D1-A90C-BB040C35D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02A8C-3BEF-4D39-8FB1-50EA0EFA3606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4E366FF-112D-459B-A77E-10A4EC7AC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5992428"/>
            <a:ext cx="4114800" cy="729048"/>
          </a:xfrm>
        </p:spPr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00BED5C-5147-4564-BE70-ED7125CAD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54723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7B65D2F-FAC7-40FE-83CD-81DED01294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1695591" y="6492875"/>
            <a:ext cx="496409" cy="365125"/>
          </a:xfrm>
        </p:spPr>
        <p:txBody>
          <a:bodyPr/>
          <a:lstStyle>
            <a:lvl1pPr>
              <a:defRPr/>
            </a:lvl1pPr>
          </a:lstStyle>
          <a:p>
            <a:fld id="{868599A2-8F95-4A95-AF80-33625A3A1802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945AA1B-BF91-4E76-88A4-8E5644252CA9}"/>
              </a:ext>
            </a:extLst>
          </p:cNvPr>
          <p:cNvSpPr/>
          <p:nvPr userDrawn="1"/>
        </p:nvSpPr>
        <p:spPr>
          <a:xfrm>
            <a:off x="0" y="143434"/>
            <a:ext cx="331694" cy="688462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タイトル 3">
            <a:extLst>
              <a:ext uri="{FF2B5EF4-FFF2-40B4-BE49-F238E27FC236}">
                <a16:creationId xmlns:a16="http://schemas.microsoft.com/office/drawing/2014/main" id="{AA88B8C2-E881-459B-A4F5-18FDDD408D13}"/>
              </a:ext>
            </a:extLst>
          </p:cNvPr>
          <p:cNvSpPr txBox="1">
            <a:spLocks/>
          </p:cNvSpPr>
          <p:nvPr userDrawn="1"/>
        </p:nvSpPr>
        <p:spPr>
          <a:xfrm>
            <a:off x="331693" y="6155767"/>
            <a:ext cx="11519995" cy="54320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 defTabSz="914264">
              <a:lnSpc>
                <a:spcPct val="100000"/>
              </a:lnSpc>
              <a:spcBef>
                <a:spcPts val="0"/>
              </a:spcBef>
              <a:defRPr/>
            </a:pPr>
            <a:endParaRPr lang="ja-JP" alt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Meiryo UI" pitchFamily="50" charset="-128"/>
              <a:ea typeface="Meiryo UI" pitchFamily="50" charset="-128"/>
              <a:cs typeface="Meiryo UI" pitchFamily="50" charset="-128"/>
            </a:endParaRPr>
          </a:p>
        </p:txBody>
      </p:sp>
      <p:sp>
        <p:nvSpPr>
          <p:cNvPr id="8" name="タイトル 3">
            <a:extLst>
              <a:ext uri="{FF2B5EF4-FFF2-40B4-BE49-F238E27FC236}">
                <a16:creationId xmlns:a16="http://schemas.microsoft.com/office/drawing/2014/main" id="{33665AFA-E69B-4DBB-A8E5-5F2C40940CBE}"/>
              </a:ext>
            </a:extLst>
          </p:cNvPr>
          <p:cNvSpPr txBox="1">
            <a:spLocks/>
          </p:cNvSpPr>
          <p:nvPr userDrawn="1"/>
        </p:nvSpPr>
        <p:spPr>
          <a:xfrm>
            <a:off x="340312" y="6148825"/>
            <a:ext cx="11519994" cy="54320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 defTabSz="914264">
              <a:lnSpc>
                <a:spcPct val="100000"/>
              </a:lnSpc>
              <a:spcBef>
                <a:spcPts val="0"/>
              </a:spcBef>
              <a:defRPr/>
            </a:pPr>
            <a:endParaRPr lang="ja-JP" alt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Meiryo UI" pitchFamily="50" charset="-128"/>
              <a:ea typeface="Meiryo UI" pitchFamily="50" charset="-128"/>
              <a:cs typeface="Meiryo UI" pitchFamily="50" charset="-128"/>
            </a:endParaRPr>
          </a:p>
        </p:txBody>
      </p:sp>
      <p:sp>
        <p:nvSpPr>
          <p:cNvPr id="9" name="コンテンツ プレースホルダー 2">
            <a:extLst>
              <a:ext uri="{FF2B5EF4-FFF2-40B4-BE49-F238E27FC236}">
                <a16:creationId xmlns:a16="http://schemas.microsoft.com/office/drawing/2014/main" id="{E44DF490-F9D8-49ED-835D-A3194FFE22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340312" y="6203841"/>
            <a:ext cx="11511376" cy="447059"/>
          </a:xfrm>
        </p:spPr>
        <p:txBody>
          <a:bodyPr>
            <a:noAutofit/>
          </a:bodyPr>
          <a:lstStyle>
            <a:lvl1pPr marL="0" indent="0" algn="ctr">
              <a:buNone/>
              <a:defRPr sz="3600" b="1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13" name="タイトル 1">
            <a:extLst>
              <a:ext uri="{FF2B5EF4-FFF2-40B4-BE49-F238E27FC236}">
                <a16:creationId xmlns:a16="http://schemas.microsoft.com/office/drawing/2014/main" id="{F6BBEBDF-D0DB-43EB-9E41-D6528AB072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0312" y="143434"/>
            <a:ext cx="10515600" cy="688462"/>
          </a:xfrm>
        </p:spPr>
        <p:txBody>
          <a:bodyPr>
            <a:normAutofit/>
          </a:bodyPr>
          <a:lstStyle>
            <a:lvl1pPr>
              <a:defRPr sz="3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1" name="正方形/長方形 1">
            <a:extLst>
              <a:ext uri="{FF2B5EF4-FFF2-40B4-BE49-F238E27FC236}">
                <a16:creationId xmlns:a16="http://schemas.microsoft.com/office/drawing/2014/main" id="{74E607DA-FBC3-4180-AA26-97F21B723ED9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10215476" y="218564"/>
            <a:ext cx="1785767" cy="507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292" tIns="45718" rIns="91292" bIns="45718">
            <a:spAutoFit/>
          </a:bodyPr>
          <a:lstStyle/>
          <a:p>
            <a:pPr defTabSz="914264">
              <a:lnSpc>
                <a:spcPct val="100000"/>
              </a:lnSpc>
              <a:spcBef>
                <a:spcPts val="0"/>
              </a:spcBef>
              <a:defRPr/>
            </a:pPr>
            <a:r>
              <a:rPr lang="en-US" altLang="ja-JP" sz="900" b="1" dirty="0">
                <a:solidFill>
                  <a:srgbClr val="C00000"/>
                </a:solidFill>
                <a:latin typeface="Meiryo UI" pitchFamily="50" charset="-128"/>
                <a:ea typeface="Meiryo UI" pitchFamily="50" charset="-128"/>
                <a:cs typeface="Meiryo UI" pitchFamily="50" charset="-128"/>
              </a:rPr>
              <a:t>Confidential</a:t>
            </a:r>
          </a:p>
          <a:p>
            <a:pPr defTabSz="914264">
              <a:lnSpc>
                <a:spcPct val="100000"/>
              </a:lnSpc>
              <a:spcBef>
                <a:spcPts val="0"/>
              </a:spcBef>
              <a:defRPr/>
            </a:pPr>
            <a:r>
              <a:rPr lang="en-US" altLang="ja-JP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Meiryo UI" pitchFamily="50" charset="-128"/>
                <a:ea typeface="Meiryo UI" pitchFamily="50" charset="-128"/>
                <a:cs typeface="Meiryo UI" pitchFamily="50" charset="-128"/>
              </a:rPr>
              <a:t>H&amp;W </a:t>
            </a:r>
            <a:r>
              <a:rPr lang="en-US" altLang="ja-JP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Meiryo UI" pitchFamily="50" charset="-128"/>
                <a:ea typeface="Meiryo UI" pitchFamily="50" charset="-128"/>
                <a:cs typeface="Meiryo UI" pitchFamily="50" charset="-128"/>
              </a:rPr>
              <a:t>Lab.,Internal</a:t>
            </a:r>
            <a:r>
              <a:rPr lang="en-US" altLang="ja-JP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Meiryo UI" pitchFamily="50" charset="-128"/>
                <a:ea typeface="Meiryo UI" pitchFamily="50" charset="-128"/>
                <a:cs typeface="Meiryo UI" pitchFamily="50" charset="-128"/>
              </a:rPr>
              <a:t> use only</a:t>
            </a:r>
          </a:p>
          <a:p>
            <a:pPr defTabSz="914264">
              <a:lnSpc>
                <a:spcPct val="100000"/>
              </a:lnSpc>
              <a:spcBef>
                <a:spcPts val="0"/>
              </a:spcBef>
              <a:defRPr/>
            </a:pPr>
            <a:r>
              <a:rPr lang="en-US" altLang="ja-JP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Meiryo UI" pitchFamily="50" charset="-128"/>
                <a:ea typeface="Meiryo UI" pitchFamily="50" charset="-128"/>
                <a:cs typeface="Meiryo UI" pitchFamily="50" charset="-128"/>
              </a:rPr>
              <a:t>Until 31/12/2050</a:t>
            </a:r>
          </a:p>
        </p:txBody>
      </p:sp>
    </p:spTree>
    <p:extLst>
      <p:ext uri="{BB962C8B-B14F-4D97-AF65-F5344CB8AC3E}">
        <p14:creationId xmlns:p14="http://schemas.microsoft.com/office/powerpoint/2010/main" val="42094733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4C529B-300E-4A1F-B801-2E363FCAB9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D66FDAE-DEF8-4CC3-A42E-F570B8B8C0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8A69F4F-2389-4A40-85D0-F68565042E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42D1DB9-151B-4C12-A74F-0B0F504AA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90F37-EDB4-4371-9541-B8B04DD0B3DA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C7839D7-428D-4BCA-8778-8F480BBED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3AB4B39-EA82-4F13-BD18-B9FE481A4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24816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BFF300-C600-48EA-96D0-B7D931F59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69CC1FD-FCC5-4EB2-845A-48EAC19D0B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993A317-B2D9-4733-BFFC-E3217B85BA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2D06848-A615-42D1-97B9-9E48CE5D6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1CAC7-9452-4AA0-AAF0-81D0BEE27E66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5E0DD63-695A-44F1-BA80-55DD15F26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61234DF-B975-491C-A1C4-551860F02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4263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4AAF08C-E72D-4CAF-BE53-00AF8208F7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ABAC5DC-736E-470A-87AD-D3C3A9E795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739D28-5418-49B8-85D8-321C857E6A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E9E7E-7A45-4BDC-B29D-5709A901FCF1}" type="datetime1">
              <a:rPr kumimoji="1" lang="ja-JP" altLang="en-US" smtClean="0"/>
              <a:t>2024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C28528-D1B5-40A5-A8FD-1A21A6A704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933E6A3-768E-4EED-A521-E1F9900E89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D8C9D-7A0B-4456-852D-4C03601A59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839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333207A-B9AA-F92C-5F5E-BD956B61F65F}"/>
              </a:ext>
            </a:extLst>
          </p:cNvPr>
          <p:cNvSpPr txBox="1"/>
          <p:nvPr/>
        </p:nvSpPr>
        <p:spPr>
          <a:xfrm>
            <a:off x="248403" y="397675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dirty="0">
                <a:effectLst/>
                <a:latin typeface="+mn-ea"/>
                <a:cs typeface="Times New Roman" panose="02020603050405020304" pitchFamily="18" charset="0"/>
              </a:rPr>
              <a:t>Supplementary Figure S1</a:t>
            </a:r>
            <a:endParaRPr lang="ja-JP" altLang="en-US" dirty="0">
              <a:latin typeface="+mn-ea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3C435BE1-FBFE-3124-811B-5871439A6A4D}"/>
              </a:ext>
            </a:extLst>
          </p:cNvPr>
          <p:cNvGrpSpPr/>
          <p:nvPr/>
        </p:nvGrpSpPr>
        <p:grpSpPr>
          <a:xfrm>
            <a:off x="2829910" y="720603"/>
            <a:ext cx="6957858" cy="5191984"/>
            <a:chOff x="2900179" y="570831"/>
            <a:chExt cx="5670168" cy="4231105"/>
          </a:xfrm>
        </p:grpSpPr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8B150E09-0B1D-AE9B-6B6E-0AEC280118A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16287281"/>
                </p:ext>
              </p:extLst>
            </p:nvPr>
          </p:nvGraphicFramePr>
          <p:xfrm>
            <a:off x="3585173" y="570831"/>
            <a:ext cx="4946650" cy="4216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2A582561-C12A-FC48-5F09-45D791DC6A1A}"/>
                </a:ext>
              </a:extLst>
            </p:cNvPr>
            <p:cNvSpPr txBox="1"/>
            <p:nvPr/>
          </p:nvSpPr>
          <p:spPr>
            <a:xfrm>
              <a:off x="6143259" y="745366"/>
              <a:ext cx="1569660" cy="4693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/>
                <a:t>6.43</a:t>
              </a:r>
              <a:endParaRPr kumimoji="1" lang="en-US" altLang="ja-JP" sz="1050" dirty="0"/>
            </a:p>
            <a:p>
              <a:pPr algn="ctr"/>
              <a:r>
                <a:rPr lang="en-US" altLang="ja-JP" sz="1050" dirty="0"/>
                <a:t>(95% CI, 3.98</a:t>
              </a:r>
              <a:r>
                <a:rPr lang="en-GB" sz="1050" dirty="0"/>
                <a:t>–</a:t>
              </a:r>
              <a:r>
                <a:rPr lang="en-US" altLang="ja-JP" sz="1050" dirty="0"/>
                <a:t>10.4)</a:t>
              </a:r>
              <a:endParaRPr kumimoji="1" lang="ja-JP" altLang="en-US" sz="1050" dirty="0"/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AC9EBED6-DD88-FE6E-3C86-E6DC502164FB}"/>
                </a:ext>
              </a:extLst>
            </p:cNvPr>
            <p:cNvSpPr txBox="1"/>
            <p:nvPr/>
          </p:nvSpPr>
          <p:spPr>
            <a:xfrm>
              <a:off x="5504957" y="2444352"/>
              <a:ext cx="1569660" cy="4693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/>
                <a:t>3.16</a:t>
              </a:r>
              <a:endParaRPr kumimoji="1" lang="en-US" altLang="ja-JP" sz="1050" dirty="0"/>
            </a:p>
            <a:p>
              <a:pPr algn="ctr"/>
              <a:r>
                <a:rPr lang="en-US" altLang="ja-JP" sz="1050" dirty="0"/>
                <a:t>(95% CI, 1.94</a:t>
              </a:r>
              <a:r>
                <a:rPr lang="en-GB" sz="1050" dirty="0"/>
                <a:t>–</a:t>
              </a:r>
              <a:r>
                <a:rPr lang="en-US" altLang="ja-JP" sz="1050" dirty="0"/>
                <a:t>5.14)</a:t>
              </a:r>
              <a:endParaRPr kumimoji="1" lang="ja-JP" altLang="en-US" sz="1050" dirty="0"/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347E341D-5161-37F2-0D68-7DD269387429}"/>
                </a:ext>
              </a:extLst>
            </p:cNvPr>
            <p:cNvSpPr txBox="1"/>
            <p:nvPr/>
          </p:nvSpPr>
          <p:spPr>
            <a:xfrm>
              <a:off x="4591874" y="2607263"/>
              <a:ext cx="1569660" cy="4693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/>
                <a:t>1.87</a:t>
              </a:r>
              <a:endParaRPr kumimoji="1" lang="en-US" altLang="ja-JP" sz="1050" dirty="0"/>
            </a:p>
            <a:p>
              <a:pPr algn="ctr"/>
              <a:r>
                <a:rPr lang="en-US" altLang="ja-JP" sz="1050" dirty="0"/>
                <a:t>(95% CI, 1.28</a:t>
              </a:r>
              <a:r>
                <a:rPr lang="en-GB" sz="1050" dirty="0"/>
                <a:t>–</a:t>
              </a:r>
              <a:r>
                <a:rPr lang="en-US" altLang="ja-JP" sz="1050" dirty="0"/>
                <a:t>2.72)</a:t>
              </a:r>
              <a:endParaRPr kumimoji="1" lang="ja-JP" altLang="en-US" sz="1050" dirty="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8822148F-CF7A-8C98-1CE3-E03BDFBE3149}"/>
                </a:ext>
              </a:extLst>
            </p:cNvPr>
            <p:cNvSpPr txBox="1"/>
            <p:nvPr/>
          </p:nvSpPr>
          <p:spPr>
            <a:xfrm>
              <a:off x="4592755" y="3452962"/>
              <a:ext cx="4892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dirty="0"/>
                <a:t>ref</a:t>
              </a:r>
              <a:endParaRPr kumimoji="1" lang="ja-JP" altLang="en-US" sz="1200" dirty="0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4AC98726-7925-062B-4B33-5D2F3A2BF26D}"/>
                </a:ext>
              </a:extLst>
            </p:cNvPr>
            <p:cNvSpPr txBox="1"/>
            <p:nvPr/>
          </p:nvSpPr>
          <p:spPr>
            <a:xfrm rot="16200000">
              <a:off x="2000733" y="2734994"/>
              <a:ext cx="21374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/>
                <a:t>Adjusted odds ratio</a:t>
              </a:r>
              <a:endParaRPr kumimoji="1" lang="ja-JP" altLang="en-US" sz="1600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DE77E1DF-CEAA-0F23-1DB7-585AF23964AC}"/>
                </a:ext>
              </a:extLst>
            </p:cNvPr>
            <p:cNvSpPr txBox="1"/>
            <p:nvPr/>
          </p:nvSpPr>
          <p:spPr>
            <a:xfrm>
              <a:off x="5732126" y="4494159"/>
              <a:ext cx="65274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/>
                <a:t>Older</a:t>
              </a:r>
              <a:endParaRPr kumimoji="1" lang="ja-JP" altLang="en-US" sz="1050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CC75A018-60C5-568B-59BC-84BBA9C1EBC3}"/>
                </a:ext>
              </a:extLst>
            </p:cNvPr>
            <p:cNvSpPr txBox="1"/>
            <p:nvPr/>
          </p:nvSpPr>
          <p:spPr>
            <a:xfrm>
              <a:off x="4207969" y="4500648"/>
              <a:ext cx="858525" cy="25081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/>
                <a:t>Non-older</a:t>
              </a:r>
              <a:endParaRPr kumimoji="1" lang="ja-JP" altLang="en-US" sz="105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D43D912-D6E5-F071-8CAC-B09674077313}"/>
                </a:ext>
              </a:extLst>
            </p:cNvPr>
            <p:cNvSpPr txBox="1"/>
            <p:nvPr/>
          </p:nvSpPr>
          <p:spPr>
            <a:xfrm>
              <a:off x="7250593" y="4156860"/>
              <a:ext cx="720889" cy="25081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/>
                <a:t>low VFA</a:t>
              </a:r>
              <a:endParaRPr kumimoji="1" lang="ja-JP" altLang="en-US" sz="1050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5BCF06EC-6077-33D0-E488-0A65B80B3DFE}"/>
                </a:ext>
              </a:extLst>
            </p:cNvPr>
            <p:cNvSpPr txBox="1"/>
            <p:nvPr/>
          </p:nvSpPr>
          <p:spPr>
            <a:xfrm>
              <a:off x="7789368" y="3780519"/>
              <a:ext cx="780979" cy="25081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high VFA</a:t>
              </a:r>
              <a:endParaRPr kumimoji="1" lang="ja-JP" altLang="en-US" sz="1050" dirty="0"/>
            </a:p>
          </p:txBody>
        </p:sp>
      </p:grpSp>
    </p:spTree>
    <p:extLst>
      <p:ext uri="{BB962C8B-B14F-4D97-AF65-F5344CB8AC3E}">
        <p14:creationId xmlns:p14="http://schemas.microsoft.com/office/powerpoint/2010/main" val="36528938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7">
      <a:majorFont>
        <a:latin typeface="Meiryo UI"/>
        <a:ea typeface="Meiryo UI"/>
        <a:cs typeface=""/>
      </a:majorFont>
      <a:minorFont>
        <a:latin typeface="Meiryo U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03</TotalTime>
  <Words>43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Meiryo UI</vt:lpstr>
      <vt:lpstr>游ゴシック</vt:lpstr>
      <vt:lpstr>Arial</vt:lpstr>
      <vt:lpstr>1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ロジスティック回帰分析(改)</dc:title>
  <dc:creator>tadashi miyazaki</dc:creator>
  <cp:lastModifiedBy>Miyazaki Tadashi (宮崎 匡史)</cp:lastModifiedBy>
  <cp:revision>626</cp:revision>
  <dcterms:created xsi:type="dcterms:W3CDTF">2023-07-19T00:14:18Z</dcterms:created>
  <dcterms:modified xsi:type="dcterms:W3CDTF">2024-08-29T07:55:28Z</dcterms:modified>
</cp:coreProperties>
</file>